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B4C447-5137-4F58-A7C2-67B16EC59BB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E3F63E-0D46-4FC8-AEB5-BDB70CC5082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B8051-5508-4933-A681-85FA3F711A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DE111B-77A6-4FC3-BECA-4FD3A78D5A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E4BCF-C0D3-497B-9B3B-BEE2732D27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C8415D-B72F-4234-8A7D-ADC8812B21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FE57E-A974-4354-A68F-22AB8A0ED6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44A5F-9AE5-4D9F-9017-9E307E7A89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C0C06-2525-4D9B-A0FA-B937C07A77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00A855-D455-454F-9CFD-61F4802A73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F3907-5094-4EBE-8198-1E317D0D41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71BDE2-EA33-4DCD-9448-1377A25F8B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C4354-6B1B-4923-8198-3D2C03AE83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CCEA5-D0B1-47C6-A01C-6F9B7357A0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2FA812-52BD-4F3C-AA20-A3C66FAB9E1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981000" y="1827360"/>
            <a:ext cx="7180200" cy="411624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1051200" y="566640"/>
            <a:ext cx="6906240" cy="58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8 Amino acid alignment of mTERF protei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rived amino acid sequences are aligned to the wheat BAC mTERF and best matches from rice and maize. Sequenc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ifferences are shaded in yellow and blue where more than one residue difference exists at that position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5T00:03:23Z</dcterms:created>
  <dc:creator> </dc:creator>
  <dc:description/>
  <dc:language>en-US</dc:language>
  <cp:lastModifiedBy>Office 2003 Registered User</cp:lastModifiedBy>
  <dcterms:modified xsi:type="dcterms:W3CDTF">2010-05-18T22:44:30Z</dcterms:modified>
  <cp:revision>2</cp:revision>
  <dc:subject/>
  <dc:title>Slide 1</dc:title>
</cp:coreProperties>
</file>